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1">
          <p15:clr>
            <a:srgbClr val="A4A3A4"/>
          </p15:clr>
        </p15:guide>
        <p15:guide id="2" pos="298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napToObjects="1" showGuides="1">
      <p:cViewPr>
        <p:scale>
          <a:sx n="80" d="100"/>
          <a:sy n="80" d="100"/>
        </p:scale>
        <p:origin x="132" y="-196"/>
      </p:cViewPr>
      <p:guideLst>
        <p:guide orient="horz" pos="2171"/>
        <p:guide pos="298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451E2D-06B3-A14A-BADF-1A9EA4A59415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4694A4-5CF1-944E-A3E9-6890100CEA5E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328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4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4745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097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097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334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8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771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755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140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329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708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Click to edit Master text styles</a:t>
            </a:r>
          </a:p>
          <a:p>
            <a:pPr lvl="1"/>
            <a:r>
              <a:rPr lang="it-IT"/>
              <a:t>Second level</a:t>
            </a:r>
          </a:p>
          <a:p>
            <a:pPr lvl="2"/>
            <a:r>
              <a:rPr lang="it-IT"/>
              <a:t>Third level</a:t>
            </a:r>
          </a:p>
          <a:p>
            <a:pPr lvl="3"/>
            <a:r>
              <a:rPr lang="it-IT"/>
              <a:t>Fourth level</a:t>
            </a:r>
          </a:p>
          <a:p>
            <a:pPr lvl="4"/>
            <a:r>
              <a:rPr lang="it-IT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FF43A-1C4E-0A4A-9EEB-32F96D2AA640}" type="datetimeFigureOut">
              <a:rPr lang="en-US" smtClean="0"/>
              <a:t>5/2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2594B-EE71-BC46-A0FA-3A9236BA545C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848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8553881"/>
              </p:ext>
            </p:extLst>
          </p:nvPr>
        </p:nvGraphicFramePr>
        <p:xfrm>
          <a:off x="1816617" y="535015"/>
          <a:ext cx="5305096" cy="5747032"/>
        </p:xfrm>
        <a:graphic>
          <a:graphicData uri="http://schemas.openxmlformats.org/drawingml/2006/table">
            <a:tbl>
              <a:tblPr/>
              <a:tblGrid>
                <a:gridCol w="229125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9659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724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5070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mortality rate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vived n (%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9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d n (%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7D3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mortalit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(77.7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 (22.3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at 30 d after Covid-19 diagnosis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 (88.2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11.8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 (78.4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21.6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 (77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23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25 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0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-50 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10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-69 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89.2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(10.7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tr-TR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70 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 (61.9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38.1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ignanc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onic lymphoid leukemia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77.8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2.2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dgkin lymphoma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(10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Hodgkin lymphoma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8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2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ltiple Myeloma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72.7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(27.3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elodysplastic syndromes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5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5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ignancy status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led disease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 (96.6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3.4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ve disease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37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 (63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 malignancy treatment before COVID-19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to-HSCT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0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vetional chemotherap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(87.5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(12.5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methylating</a:t>
                      </a:r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gents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5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(5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-chemotherap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 (8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2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rgeted therap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 (71.4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28.5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 the last 3 months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 (74.1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 (25.9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id-19 infection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ymptomatic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(90.9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(9.1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ld 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 (86.3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(13.6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rate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 (8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2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vere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(68.7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31.2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itical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(100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id-19 symptoms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lmonar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 (77.6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 (22.4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59895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trapulmonary</a:t>
                      </a:r>
                    </a:p>
                  </a:txBody>
                  <a:tcPr marL="8614" marR="8614" marT="8614" marB="0" anchor="b">
                    <a:lnL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 (86.7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(13.3)</a:t>
                      </a:r>
                    </a:p>
                  </a:txBody>
                  <a:tcPr marL="8614" marR="8614" marT="8614" marB="0" anchor="b">
                    <a:lnL>
                      <a:noFill/>
                    </a:lnL>
                    <a:lnR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F4B084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-81644" y="-15116"/>
            <a:ext cx="5804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.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Table 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verall mortality by baseline characteristics and treatment received</a:t>
            </a:r>
          </a:p>
        </p:txBody>
      </p:sp>
    </p:spTree>
    <p:extLst>
      <p:ext uri="{BB962C8B-B14F-4D97-AF65-F5344CB8AC3E}">
        <p14:creationId xmlns:p14="http://schemas.microsoft.com/office/powerpoint/2010/main" val="3313097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4</Words>
  <Application>Microsoft Office PowerPoint</Application>
  <PresentationFormat>Presentazione su schermo (4:3)</PresentationFormat>
  <Paragraphs>9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e</dc:creator>
  <cp:lastModifiedBy>Daniele Caracciolo</cp:lastModifiedBy>
  <cp:revision>107</cp:revision>
  <dcterms:created xsi:type="dcterms:W3CDTF">2024-10-12T13:22:48Z</dcterms:created>
  <dcterms:modified xsi:type="dcterms:W3CDTF">2025-05-25T19:55:39Z</dcterms:modified>
</cp:coreProperties>
</file>